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14511-A4E1-4196-B7B1-204A3CC230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22A28-C33F-4039-BE25-4EB9201007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F4B08-BA1B-4E72-9E45-F65B376E84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4DE8E-0B86-47AC-8E85-EE50B41CD8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313FA-56A9-4292-B56C-EA9A2C7754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9EB47-D47D-4EF9-B99B-2C320BF6EF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E90519-F44F-4A37-A673-2A4A803ACE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18E7B-9EC5-40B9-AF72-29EC8ED799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3894E-8960-4934-BB71-681639865A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1AB0B-98DF-496B-A403-C1FF35A385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4B8DB-0759-4CE1-B58A-403D53C477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F330D7-B8CB-41F8-B547-7451FF53FA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E53C8B-CE80-414A-9F57-6D77E77C02D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Heat maps of sets in A_LB(0.1)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upplement to 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Gene set enrichment analysis for non-monotone assocation and multiple experimental categories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by Lin.et al(2008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4 PROPANOATE_METABOLISM (blood)</a:t>
            </a: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304920" y="2362320"/>
            <a:ext cx="11201400" cy="247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5 EIF2PATHWAY (liver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228600" y="1371600"/>
            <a:ext cx="11582280" cy="5105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5 EIF2PATHWAY (blood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457200" y="1447920"/>
            <a:ext cx="10972800" cy="510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elected sets in 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B</a:t>
            </a: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(0.1) with size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YRUVATE_METABOLISM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4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GLYCOLYSIS_AND_GLUCONEOGENESIS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4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RANSLATION_FACTORS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ROPANOATE_METABOLISM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36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5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IF2PATHWAY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ukaryotic initiation factor 2 (EIF2) initiates translation by transferring Met-tRNA to the 40S ribosome in a GTP-dependent process.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1 PYRUVATE_METABOLISM (liver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228600" y="838080"/>
            <a:ext cx="11430000" cy="5639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1 PYRUVATE_METABOLISM (blood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11430000" cy="5257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2: GLYCOLYSIS_AND_GLUCONEOGENESIS (liver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533520" y="990720"/>
            <a:ext cx="10972800" cy="5562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2: GLYCOLYSIS_AND_GLUCONEOGENESIS (blood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11277720" cy="5334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3 TRANSLATION_FACTORS (liver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228600" y="1523880"/>
            <a:ext cx="11430000" cy="4724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t 3 TRANSLATION_FACTORS (blood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304920" y="1752480"/>
            <a:ext cx="11582280" cy="490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t 4 PROPANOATE_METABOLISM (liver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380880" y="2666880"/>
            <a:ext cx="11049120" cy="2667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4T17:12:04Z</dcterms:created>
  <dc:creator>li3</dc:creator>
  <dc:description/>
  <dc:language>en-US</dc:language>
  <cp:lastModifiedBy>University of Massachusetts</cp:lastModifiedBy>
  <dcterms:modified xsi:type="dcterms:W3CDTF">2008-09-15T15:47:23Z</dcterms:modified>
  <cp:revision>18</cp:revision>
  <dc:subject/>
  <dc:title>Slide 1</dc:title>
</cp:coreProperties>
</file>